
<file path=[Content_Types].xml><?xml version="1.0" encoding="utf-8"?>
<Types xmlns="http://schemas.openxmlformats.org/package/2006/content-types">
  <Default Extension="rels" ContentType="application/vnd.openxmlformats-package.relationships+xml"/>
  <Default Extension="tiff" ContentType="image/tiff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81" r:id="rId2"/>
  </p:sldIdLst>
  <p:sldSz cx="6858000" cy="9144000" type="screen4x3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989" userDrawn="1">
          <p15:clr>
            <a:srgbClr val="A4A3A4"/>
          </p15:clr>
        </p15:guide>
        <p15:guide id="2" pos="247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5C2C6"/>
    <a:srgbClr val="58CAE8"/>
    <a:srgbClr val="00FA7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Estilo claro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77" autoAdjust="0"/>
    <p:restoredTop sz="93842" autoAdjust="0"/>
  </p:normalViewPr>
  <p:slideViewPr>
    <p:cSldViewPr snapToGrid="0" snapToObjects="1">
      <p:cViewPr varScale="1">
        <p:scale>
          <a:sx n="48" d="100"/>
          <a:sy n="48" d="100"/>
        </p:scale>
        <p:origin x="2048" y="28"/>
      </p:cViewPr>
      <p:guideLst>
        <p:guide orient="horz" pos="4989"/>
        <p:guide pos="2478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AFD-46D6-8F13-50D18CA47386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R$402:$R$404</c:f>
                <c:numCache>
                  <c:formatCode>General</c:formatCode>
                  <c:ptCount val="3"/>
                  <c:pt idx="0">
                    <c:v>0.77</c:v>
                  </c:pt>
                  <c:pt idx="1">
                    <c:v>2.7</c:v>
                  </c:pt>
                  <c:pt idx="2">
                    <c:v>1.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P$402:$P$404</c:f>
              <c:strCache>
                <c:ptCount val="3"/>
                <c:pt idx="0">
                  <c:v>alveoli</c:v>
                </c:pt>
                <c:pt idx="1">
                  <c:v>alveoli</c:v>
                </c:pt>
                <c:pt idx="2">
                  <c:v>tumor</c:v>
                </c:pt>
              </c:strCache>
            </c:strRef>
          </c:cat>
          <c:val>
            <c:numRef>
              <c:f>Sheet1!$Q$402:$Q$404</c:f>
              <c:numCache>
                <c:formatCode>General</c:formatCode>
                <c:ptCount val="3"/>
                <c:pt idx="0">
                  <c:v>10.090833333333334</c:v>
                </c:pt>
                <c:pt idx="1">
                  <c:v>14.913</c:v>
                </c:pt>
                <c:pt idx="2">
                  <c:v>12.4416666666666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AFD-46D6-8F13-50D18CA4738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94018799"/>
        <c:axId val="594022127"/>
      </c:barChart>
      <c:catAx>
        <c:axId val="59401879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400" b="0" i="0" u="none" strike="noStrike" kern="1200" baseline="0">
                <a:solidFill>
                  <a:schemeClr val="bg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594022127"/>
        <c:crosses val="autoZero"/>
        <c:auto val="1"/>
        <c:lblAlgn val="ctr"/>
        <c:lblOffset val="100"/>
        <c:noMultiLvlLbl val="0"/>
      </c:catAx>
      <c:valAx>
        <c:axId val="594022127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bg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ES" sz="80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PC+pSMAD3+ cells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bg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s-E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59401879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029666-E4F6-5046-93D6-2C0E6FFFF757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90A131-55CD-9444-BE72-F77607F90F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06856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39433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59704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05000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29615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85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42790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9017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61767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6704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1682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0725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55098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53012AD4-FBF0-48EB-A8BC-00DCB1B0999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22471869"/>
              </p:ext>
            </p:extLst>
          </p:nvPr>
        </p:nvGraphicFramePr>
        <p:xfrm>
          <a:off x="5133099" y="3379643"/>
          <a:ext cx="1694794" cy="13836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74FBD0AD-8498-4005-9992-5774506123A6}"/>
              </a:ext>
            </a:extLst>
          </p:cNvPr>
          <p:cNvSpPr txBox="1"/>
          <p:nvPr/>
        </p:nvSpPr>
        <p:spPr>
          <a:xfrm>
            <a:off x="5594030" y="4671086"/>
            <a:ext cx="13168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UbiCR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UbiCR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::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              V600E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9925DD5-FB0D-48A8-A8E2-7C3533D7901F}"/>
              </a:ext>
            </a:extLst>
          </p:cNvPr>
          <p:cNvSpPr txBox="1"/>
          <p:nvPr/>
        </p:nvSpPr>
        <p:spPr>
          <a:xfrm>
            <a:off x="5655909" y="4559654"/>
            <a:ext cx="13259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lveoli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lveoli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tumor</a:t>
            </a:r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4F2447C4-015B-4AD9-BED5-F234613F56AB}"/>
              </a:ext>
            </a:extLst>
          </p:cNvPr>
          <p:cNvCxnSpPr/>
          <p:nvPr/>
        </p:nvCxnSpPr>
        <p:spPr>
          <a:xfrm>
            <a:off x="6111204" y="4728484"/>
            <a:ext cx="57042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01BB2E14-EA07-415A-B479-E9C2B135A644}"/>
              </a:ext>
            </a:extLst>
          </p:cNvPr>
          <p:cNvCxnSpPr/>
          <p:nvPr/>
        </p:nvCxnSpPr>
        <p:spPr>
          <a:xfrm>
            <a:off x="5763551" y="4728484"/>
            <a:ext cx="28065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C091D10C-F906-49A6-BFED-21D672D9304F}"/>
              </a:ext>
            </a:extLst>
          </p:cNvPr>
          <p:cNvSpPr txBox="1"/>
          <p:nvPr/>
        </p:nvSpPr>
        <p:spPr>
          <a:xfrm>
            <a:off x="6348960" y="3634233"/>
            <a:ext cx="4073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9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EB264DF-03A2-4930-9172-861670A4AA11}"/>
              </a:ext>
            </a:extLst>
          </p:cNvPr>
          <p:cNvSpPr txBox="1"/>
          <p:nvPr/>
        </p:nvSpPr>
        <p:spPr>
          <a:xfrm>
            <a:off x="6041870" y="3460285"/>
            <a:ext cx="4706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0BD754E-22D1-4D3A-8D57-1759EDFF407D}"/>
              </a:ext>
            </a:extLst>
          </p:cNvPr>
          <p:cNvSpPr txBox="1"/>
          <p:nvPr/>
        </p:nvSpPr>
        <p:spPr>
          <a:xfrm>
            <a:off x="5731084" y="3842459"/>
            <a:ext cx="4706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6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72AAD1A-62CC-44B7-8D15-D5E438C0CAD0}"/>
              </a:ext>
            </a:extLst>
          </p:cNvPr>
          <p:cNvSpPr txBox="1"/>
          <p:nvPr/>
        </p:nvSpPr>
        <p:spPr>
          <a:xfrm rot="16200000">
            <a:off x="4611375" y="3950181"/>
            <a:ext cx="1778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SPC+ pSMAD3+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(%)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A4F6EFF9-8F5E-4DBF-B04A-53DB2CF564E0}"/>
              </a:ext>
            </a:extLst>
          </p:cNvPr>
          <p:cNvCxnSpPr>
            <a:cxnSpLocks/>
          </p:cNvCxnSpPr>
          <p:nvPr/>
        </p:nvCxnSpPr>
        <p:spPr>
          <a:xfrm>
            <a:off x="6298178" y="3509848"/>
            <a:ext cx="41251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DD4158AF-8DBF-47CA-B65F-432027E6AB6A}"/>
              </a:ext>
            </a:extLst>
          </p:cNvPr>
          <p:cNvSpPr txBox="1"/>
          <p:nvPr/>
        </p:nvSpPr>
        <p:spPr>
          <a:xfrm>
            <a:off x="6215784" y="3345798"/>
            <a:ext cx="706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P=0.32 ns</a:t>
            </a:r>
            <a:endParaRPr lang="it-IT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9B574712-E750-4111-8CB2-20E0A105930C}"/>
              </a:ext>
            </a:extLst>
          </p:cNvPr>
          <p:cNvCxnSpPr>
            <a:cxnSpLocks/>
          </p:cNvCxnSpPr>
          <p:nvPr/>
        </p:nvCxnSpPr>
        <p:spPr>
          <a:xfrm>
            <a:off x="5815948" y="3507858"/>
            <a:ext cx="41251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F833F090-46C4-4316-B5C5-0C7156CEC7B9}"/>
              </a:ext>
            </a:extLst>
          </p:cNvPr>
          <p:cNvSpPr txBox="1"/>
          <p:nvPr/>
        </p:nvSpPr>
        <p:spPr>
          <a:xfrm>
            <a:off x="5672392" y="3345798"/>
            <a:ext cx="7439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P=0.18 ns</a:t>
            </a:r>
            <a:endParaRPr lang="it-IT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C57E71F2-363A-4749-BABB-A51CA90BDCF7}"/>
              </a:ext>
            </a:extLst>
          </p:cNvPr>
          <p:cNvCxnSpPr>
            <a:cxnSpLocks/>
          </p:cNvCxnSpPr>
          <p:nvPr/>
        </p:nvCxnSpPr>
        <p:spPr>
          <a:xfrm>
            <a:off x="5903180" y="3363204"/>
            <a:ext cx="71686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1D151B5A-BE9B-4E94-8835-D37A591C0E9F}"/>
              </a:ext>
            </a:extLst>
          </p:cNvPr>
          <p:cNvSpPr txBox="1"/>
          <p:nvPr/>
        </p:nvSpPr>
        <p:spPr>
          <a:xfrm>
            <a:off x="5903180" y="3195133"/>
            <a:ext cx="7950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P=0.85 ns</a:t>
            </a:r>
            <a:endParaRPr lang="it-IT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8D304CD8-E759-491E-AFE9-DE9B9F4B937F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826452" y="3283190"/>
            <a:ext cx="1694803" cy="1572983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15F3F454-272A-437D-9C4D-D2240FC33CA6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4936" y="3290617"/>
            <a:ext cx="1629800" cy="1574423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3A4B8F4E-123E-4541-BC2E-A6A2A7D344AF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635776" y="3283514"/>
            <a:ext cx="1644564" cy="1575945"/>
          </a:xfrm>
          <a:prstGeom prst="rect">
            <a:avLst/>
          </a:prstGeom>
        </p:spPr>
      </p:pic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3AB64FBF-8CB0-425C-B77E-1916333D5C41}"/>
              </a:ext>
            </a:extLst>
          </p:cNvPr>
          <p:cNvCxnSpPr>
            <a:cxnSpLocks/>
          </p:cNvCxnSpPr>
          <p:nvPr/>
        </p:nvCxnSpPr>
        <p:spPr>
          <a:xfrm>
            <a:off x="1306993" y="4818523"/>
            <a:ext cx="34808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ABA49AA1-C62F-4D3D-AF91-A66DB0A9A8E0}"/>
              </a:ext>
            </a:extLst>
          </p:cNvPr>
          <p:cNvSpPr txBox="1"/>
          <p:nvPr/>
        </p:nvSpPr>
        <p:spPr>
          <a:xfrm>
            <a:off x="1296361" y="4677449"/>
            <a:ext cx="42714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50um</a:t>
            </a:r>
          </a:p>
        </p:txBody>
      </p: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BB179C1B-7DBB-4E97-B15E-97D1024A48FA}"/>
              </a:ext>
            </a:extLst>
          </p:cNvPr>
          <p:cNvCxnSpPr/>
          <p:nvPr/>
        </p:nvCxnSpPr>
        <p:spPr>
          <a:xfrm flipV="1">
            <a:off x="4645514" y="4014824"/>
            <a:ext cx="108111" cy="130476"/>
          </a:xfrm>
          <a:prstGeom prst="straightConnector1">
            <a:avLst/>
          </a:prstGeom>
          <a:ln w="9525">
            <a:solidFill>
              <a:schemeClr val="tx1"/>
            </a:solidFill>
            <a:headEnd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1254B335-C6B1-40C1-9498-9F902896065D}"/>
              </a:ext>
            </a:extLst>
          </p:cNvPr>
          <p:cNvCxnSpPr/>
          <p:nvPr/>
        </p:nvCxnSpPr>
        <p:spPr>
          <a:xfrm flipV="1">
            <a:off x="2545935" y="4096729"/>
            <a:ext cx="108111" cy="130476"/>
          </a:xfrm>
          <a:prstGeom prst="straightConnector1">
            <a:avLst/>
          </a:prstGeom>
          <a:ln w="9525">
            <a:solidFill>
              <a:schemeClr val="tx1"/>
            </a:solidFill>
            <a:headEnd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51CD55CE-5318-4547-B867-ADF3F87C1197}"/>
              </a:ext>
            </a:extLst>
          </p:cNvPr>
          <p:cNvCxnSpPr/>
          <p:nvPr/>
        </p:nvCxnSpPr>
        <p:spPr>
          <a:xfrm flipV="1">
            <a:off x="782329" y="4329354"/>
            <a:ext cx="108111" cy="130476"/>
          </a:xfrm>
          <a:prstGeom prst="straightConnector1">
            <a:avLst/>
          </a:prstGeom>
          <a:ln w="9525">
            <a:solidFill>
              <a:schemeClr val="tx1"/>
            </a:solidFill>
            <a:headEnd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F391B19B-D3C6-4FD7-963A-6EEC29AE0E68}"/>
              </a:ext>
            </a:extLst>
          </p:cNvPr>
          <p:cNvSpPr txBox="1"/>
          <p:nvPr/>
        </p:nvSpPr>
        <p:spPr>
          <a:xfrm>
            <a:off x="-43481" y="3345798"/>
            <a:ext cx="6449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solidFill>
                  <a:srgbClr val="8E766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SMAD3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19663D7-D1B9-4871-8802-37D42A911BA8}"/>
              </a:ext>
            </a:extLst>
          </p:cNvPr>
          <p:cNvSpPr txBox="1"/>
          <p:nvPr/>
        </p:nvSpPr>
        <p:spPr>
          <a:xfrm>
            <a:off x="-43482" y="3252573"/>
            <a:ext cx="7753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solidFill>
                  <a:srgbClr val="BA0CA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C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86A3D9AF-C44A-4A4E-A37B-6FDF7D7F2C16}"/>
              </a:ext>
            </a:extLst>
          </p:cNvPr>
          <p:cNvSpPr txBox="1"/>
          <p:nvPr/>
        </p:nvSpPr>
        <p:spPr>
          <a:xfrm>
            <a:off x="1742812" y="3331301"/>
            <a:ext cx="6449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solidFill>
                  <a:srgbClr val="8E766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SMAD3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14AA7A36-86F7-4CCA-A535-05C6703AE03A}"/>
              </a:ext>
            </a:extLst>
          </p:cNvPr>
          <p:cNvSpPr txBox="1"/>
          <p:nvPr/>
        </p:nvSpPr>
        <p:spPr>
          <a:xfrm>
            <a:off x="1742811" y="3238076"/>
            <a:ext cx="7753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solidFill>
                  <a:srgbClr val="BA0CA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C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A107D274-44B2-49F1-834A-CB523EA2AD09}"/>
              </a:ext>
            </a:extLst>
          </p:cNvPr>
          <p:cNvSpPr txBox="1"/>
          <p:nvPr/>
        </p:nvSpPr>
        <p:spPr>
          <a:xfrm>
            <a:off x="3552136" y="3345798"/>
            <a:ext cx="6449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solidFill>
                  <a:srgbClr val="8E766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SMAD3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9EFEA449-FDB5-48CA-94A3-18237842D206}"/>
              </a:ext>
            </a:extLst>
          </p:cNvPr>
          <p:cNvSpPr txBox="1"/>
          <p:nvPr/>
        </p:nvSpPr>
        <p:spPr>
          <a:xfrm>
            <a:off x="3552135" y="3252573"/>
            <a:ext cx="7753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solidFill>
                  <a:srgbClr val="BA0CA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C</a:t>
            </a:r>
          </a:p>
        </p:txBody>
      </p:sp>
      <p:sp>
        <p:nvSpPr>
          <p:cNvPr id="37" name="Rectangle 731">
            <a:extLst>
              <a:ext uri="{FF2B5EF4-FFF2-40B4-BE49-F238E27FC236}">
                <a16:creationId xmlns:a16="http://schemas.microsoft.com/office/drawing/2014/main" id="{9B11FF30-678D-41C3-B485-6670029C67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-52030" y="-32625"/>
            <a:ext cx="227889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eaLnBrk="1" hangingPunct="1"/>
            <a:r>
              <a:rPr lang="es-ES_tradnl" sz="1200" dirty="0">
                <a:latin typeface="Arial"/>
                <a:cs typeface="Arial"/>
              </a:rPr>
              <a:t>SUPPLEMENTARY FIGURE 7</a:t>
            </a:r>
          </a:p>
        </p:txBody>
      </p: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DA8883C5-CAA5-4C09-AB4C-D884A5751DDF}"/>
              </a:ext>
            </a:extLst>
          </p:cNvPr>
          <p:cNvCxnSpPr>
            <a:cxnSpLocks/>
          </p:cNvCxnSpPr>
          <p:nvPr/>
        </p:nvCxnSpPr>
        <p:spPr>
          <a:xfrm>
            <a:off x="3145668" y="4812073"/>
            <a:ext cx="34808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59F42BD7-1C12-4CE5-BF4F-B94B1912FE2B}"/>
              </a:ext>
            </a:extLst>
          </p:cNvPr>
          <p:cNvSpPr txBox="1"/>
          <p:nvPr/>
        </p:nvSpPr>
        <p:spPr>
          <a:xfrm>
            <a:off x="3135036" y="4670999"/>
            <a:ext cx="42714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50um</a:t>
            </a:r>
          </a:p>
        </p:txBody>
      </p: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BECB526E-3151-4646-AB25-D4C7667D9468}"/>
              </a:ext>
            </a:extLst>
          </p:cNvPr>
          <p:cNvCxnSpPr>
            <a:cxnSpLocks/>
          </p:cNvCxnSpPr>
          <p:nvPr/>
        </p:nvCxnSpPr>
        <p:spPr>
          <a:xfrm>
            <a:off x="4911591" y="4811648"/>
            <a:ext cx="34808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07DB5911-8537-43A6-9175-E415FCEDC8D6}"/>
              </a:ext>
            </a:extLst>
          </p:cNvPr>
          <p:cNvSpPr txBox="1"/>
          <p:nvPr/>
        </p:nvSpPr>
        <p:spPr>
          <a:xfrm>
            <a:off x="4900959" y="4670574"/>
            <a:ext cx="42714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50um</a:t>
            </a:r>
          </a:p>
        </p:txBody>
      </p:sp>
    </p:spTree>
    <p:extLst>
      <p:ext uri="{BB962C8B-B14F-4D97-AF65-F5344CB8AC3E}">
        <p14:creationId xmlns:p14="http://schemas.microsoft.com/office/powerpoint/2010/main" val="39175216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733</TotalTime>
  <Words>54</Words>
  <Application>Microsoft Office PowerPoint</Application>
  <PresentationFormat>On-screen Show (4:3)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n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n non</dc:creator>
  <cp:lastModifiedBy>Chromosome Walker</cp:lastModifiedBy>
  <cp:revision>1224</cp:revision>
  <cp:lastPrinted>2019-05-07T09:00:55Z</cp:lastPrinted>
  <dcterms:created xsi:type="dcterms:W3CDTF">2015-10-02T08:08:01Z</dcterms:created>
  <dcterms:modified xsi:type="dcterms:W3CDTF">2021-11-20T12:04:10Z</dcterms:modified>
</cp:coreProperties>
</file>